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12192000" cy="6858000"/>
  <p:notesSz cx="6858000" cy="994727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81" d="100"/>
          <a:sy n="81" d="100"/>
        </p:scale>
        <p:origin x="-102" y="-66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99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0CB566-3B20-4154-A778-75285434B7EA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44500" y="1243013"/>
            <a:ext cx="5969000" cy="33575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787126"/>
            <a:ext cx="5486400" cy="391674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9448185"/>
            <a:ext cx="2971800" cy="499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E726D09-22FA-4882-9C88-E540C433E568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2650077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187851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116594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319000906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609600" y="274639"/>
            <a:ext cx="10972800" cy="5851525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3" name="Rectangle 4">
            <a:extLst>
              <a:ext uri="{FF2B5EF4-FFF2-40B4-BE49-F238E27FC236}">
                <a16:creationId xmlns:a16="http://schemas.microsoft.com/office/drawing/2014/main" xmlns="" id="{D07C8E89-CA08-4FDD-8243-ECECF9EF71BB}"/>
              </a:ext>
            </a:extLst>
          </p:cNvPr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4" name="Rectangle 5">
            <a:extLst>
              <a:ext uri="{FF2B5EF4-FFF2-40B4-BE49-F238E27FC236}">
                <a16:creationId xmlns:a16="http://schemas.microsoft.com/office/drawing/2014/main" xmlns="" id="{99433B9F-20B7-40EF-9D0F-B082E5CF0F91}"/>
              </a:ext>
            </a:extLst>
          </p:cNvPr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zh-CN"/>
          </a:p>
        </p:txBody>
      </p:sp>
      <p:sp>
        <p:nvSpPr>
          <p:cNvPr id="5" name="Rectangle 6">
            <a:extLst>
              <a:ext uri="{FF2B5EF4-FFF2-40B4-BE49-F238E27FC236}">
                <a16:creationId xmlns:a16="http://schemas.microsoft.com/office/drawing/2014/main" xmlns="" id="{3600D71F-D712-4988-8D6B-C3A8465A30C4}"/>
              </a:ext>
            </a:extLst>
          </p:cNvPr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E1A33DB-13CC-4D99-8BCC-34AE9FC60BA5}" type="slidenum">
              <a:rPr lang="en-US" altLang="zh-CN"/>
              <a:pPr>
                <a:defRPr/>
              </a:pPr>
              <a:t>‹#›</a:t>
            </a:fld>
            <a:endParaRPr lang="en-US" altLang="zh-CN"/>
          </a:p>
        </p:txBody>
      </p:sp>
    </p:spTree>
    <p:extLst>
      <p:ext uri="{BB962C8B-B14F-4D97-AF65-F5344CB8AC3E}">
        <p14:creationId xmlns:p14="http://schemas.microsoft.com/office/powerpoint/2010/main" xmlns="" val="21792096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002488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873118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3992824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4635411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689847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994318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7225272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319166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88F8CA6-399B-4918-8F4B-292564F58E24}" type="datetimeFigureOut">
              <a:rPr lang="zh-CN" altLang="en-US" smtClean="0"/>
              <a:pPr/>
              <a:t>2018/10/27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CFC837-AA7B-4BD9-9181-650E0389EF6A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xmlns="" val="2454135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624207755"/>
              </p:ext>
            </p:extLst>
          </p:nvPr>
        </p:nvGraphicFramePr>
        <p:xfrm>
          <a:off x="496959" y="924334"/>
          <a:ext cx="10744200" cy="5138540"/>
        </p:xfrm>
        <a:graphic>
          <a:graphicData uri="http://schemas.openxmlformats.org/drawingml/2006/table">
            <a:tbl>
              <a:tblPr/>
              <a:tblGrid>
                <a:gridCol w="1551312">
                  <a:extLst>
                    <a:ext uri="{9D8B030D-6E8A-4147-A177-3AD203B41FA5}">
                      <a16:colId xmlns:a16="http://schemas.microsoft.com/office/drawing/2014/main" xmlns="" val="1112785415"/>
                    </a:ext>
                  </a:extLst>
                </a:gridCol>
                <a:gridCol w="774442">
                  <a:extLst>
                    <a:ext uri="{9D8B030D-6E8A-4147-A177-3AD203B41FA5}">
                      <a16:colId xmlns:a16="http://schemas.microsoft.com/office/drawing/2014/main" xmlns="" val="2928984288"/>
                    </a:ext>
                  </a:extLst>
                </a:gridCol>
                <a:gridCol w="815009">
                  <a:extLst>
                    <a:ext uri="{9D8B030D-6E8A-4147-A177-3AD203B41FA5}">
                      <a16:colId xmlns:a16="http://schemas.microsoft.com/office/drawing/2014/main" xmlns="" val="3739374741"/>
                    </a:ext>
                  </a:extLst>
                </a:gridCol>
                <a:gridCol w="795130">
                  <a:extLst>
                    <a:ext uri="{9D8B030D-6E8A-4147-A177-3AD203B41FA5}">
                      <a16:colId xmlns:a16="http://schemas.microsoft.com/office/drawing/2014/main" xmlns="" val="3888517639"/>
                    </a:ext>
                  </a:extLst>
                </a:gridCol>
                <a:gridCol w="880561">
                  <a:extLst>
                    <a:ext uri="{9D8B030D-6E8A-4147-A177-3AD203B41FA5}">
                      <a16:colId xmlns:a16="http://schemas.microsoft.com/office/drawing/2014/main" xmlns="" val="1864436936"/>
                    </a:ext>
                  </a:extLst>
                </a:gridCol>
                <a:gridCol w="570552">
                  <a:extLst>
                    <a:ext uri="{9D8B030D-6E8A-4147-A177-3AD203B41FA5}">
                      <a16:colId xmlns:a16="http://schemas.microsoft.com/office/drawing/2014/main" xmlns="" val="2453624037"/>
                    </a:ext>
                  </a:extLst>
                </a:gridCol>
                <a:gridCol w="5357194">
                  <a:extLst>
                    <a:ext uri="{9D8B030D-6E8A-4147-A177-3AD203B41FA5}">
                      <a16:colId xmlns:a16="http://schemas.microsoft.com/office/drawing/2014/main" xmlns="" val="396749489"/>
                    </a:ext>
                  </a:extLst>
                </a:gridCol>
              </a:tblGrid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Access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T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c1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g2 ratio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value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DR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Description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902425254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12g1760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869.1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6855.7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.3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3983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ribulose bisphosphate carboxylase small chain, chloroplast precursor,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utativ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81993673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4g3860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738.3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0461.3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.8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84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yceraldehyde-3-phosphate dehydrogen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09750711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3g0730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95.2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99.5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.5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56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ribulose-phosphate 3-epimerase, chloroplast precursor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25317190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10g21268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4903.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77123.9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.1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1792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ribulose bisphosphate carboxylase large chain precursor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404431683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2g0583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130.4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4632.8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85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1735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ribulose bisphosphate carboxylase small chain, chloroplast precursor, 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utative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562434670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3g0372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155.6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2972.7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5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13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glyceraldehyde-3-phosphate dehydrogen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43011386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2g4702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839.2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4072.5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2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821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hosphoribulokinas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/Uridine kinase family protein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23355848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11g0702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399.1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0543.7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19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27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ructose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isphospat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aldolase isozym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929463004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4g1668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58.9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862.8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1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607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ructose-1,6-bisphosphat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680344598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8g0270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27.3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90.1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11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316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ructose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isphospat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aldolase isozym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97784215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5g41640.3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7089.1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4862.1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.1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538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hosphoglycerate kinase protein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859920019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1g5250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000.7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590.5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92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37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NADP-dependent malic enzym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582987945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6g4064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005.5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608.8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8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14049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fructose-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bisphospat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aldolase isozym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822361268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5g3357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504.8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151.8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76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24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yruvate, phosphate dikinase, chloroplast precursor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207159125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6g0427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1900.8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0751.9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74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8.41E-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transketolase, chloroplast precursor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80141620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8g4481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3912.0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6591.5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6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5.93E-05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actate/malate dehydrogen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458960209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3g5628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906.9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517.6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6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3094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actate/malate dehydrogenase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00718139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3g15050.2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403.8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2285.7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6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3057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phosphoenolpyruvate </a:t>
                      </a:r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carboxykinas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231104594"/>
                  </a:ext>
                </a:extLst>
              </a:tr>
              <a:tr h="256927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LOC_Os09g36450.1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0551.53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6680.47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1.58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1224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0.000 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triosephosphate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  <a:cs typeface="Arial" panose="020B0604020202020204" pitchFamily="34" charset="0"/>
                        </a:rPr>
                        <a:t> isomerase, chloroplast precursor, putative, expressed</a:t>
                      </a:r>
                    </a:p>
                  </a:txBody>
                  <a:tcPr marL="6350" marR="6350" marT="63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086553694"/>
                  </a:ext>
                </a:extLst>
              </a:tr>
            </a:tbl>
          </a:graphicData>
        </a:graphic>
      </p:graphicFrame>
      <p:sp>
        <p:nvSpPr>
          <p:cNvPr id="4" name="矩形 3"/>
          <p:cNvSpPr/>
          <p:nvPr/>
        </p:nvSpPr>
        <p:spPr>
          <a:xfrm>
            <a:off x="384311" y="487017"/>
            <a:ext cx="103002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400" b="1" kern="0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sz="1400" b="1" kern="0" dirty="0" smtClean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  <a:r>
              <a:rPr lang="en-US" altLang="zh-CN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1.5-fold 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alterations of proteins involved in carbon fixation in comparison of </a:t>
            </a:r>
            <a:r>
              <a:rPr lang="en-US" altLang="zh-CN" sz="1400" i="1" dirty="0">
                <a:latin typeface="Arial" panose="020B0604020202020204" pitchFamily="34" charset="0"/>
                <a:cs typeface="Arial" panose="020B0604020202020204" pitchFamily="34" charset="0"/>
              </a:rPr>
              <a:t>fc17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400" dirty="0" err="1">
                <a:latin typeface="Arial" panose="020B0604020202020204" pitchFamily="34" charset="0"/>
                <a:cs typeface="Arial" panose="020B0604020202020204" pitchFamily="34" charset="0"/>
              </a:rPr>
              <a:t>iTRAQ</a:t>
            </a:r>
            <a:r>
              <a:rPr lang="en-US" altLang="zh-CN" sz="1400" dirty="0">
                <a:latin typeface="Arial" panose="020B0604020202020204" pitchFamily="34" charset="0"/>
                <a:cs typeface="Arial" panose="020B0604020202020204" pitchFamily="34" charset="0"/>
              </a:rPr>
              <a:t> data to that of the WT</a:t>
            </a:r>
            <a:endParaRPr lang="zh-CN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21266072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35</TotalTime>
  <Words>289</Words>
  <Application>Microsoft Office PowerPoint</Application>
  <PresentationFormat>Custom</PresentationFormat>
  <Paragraphs>14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0012761</cp:lastModifiedBy>
  <cp:revision>97</cp:revision>
  <cp:lastPrinted>2018-10-21T01:09:07Z</cp:lastPrinted>
  <dcterms:created xsi:type="dcterms:W3CDTF">2018-01-28T13:46:17Z</dcterms:created>
  <dcterms:modified xsi:type="dcterms:W3CDTF">2018-10-27T12:46:34Z</dcterms:modified>
</cp:coreProperties>
</file>